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3"/>
    <p:restoredTop sz="94689"/>
  </p:normalViewPr>
  <p:slideViewPr>
    <p:cSldViewPr snapToGrid="0" snapToObjects="1">
      <p:cViewPr varScale="1">
        <p:scale>
          <a:sx n="90" d="100"/>
          <a:sy n="90" d="100"/>
        </p:scale>
        <p:origin x="232" y="7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eilobrien/Desktop/Academic%20Projects/Alexandra%20and%20Cydney%20and%20Emily%20and%20Students/Emily%20SRP/Palbo%20vs%20LEE/Breast%20-%20LEE011%20-%20DataViewer.xlsm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IC5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42C4-BB45-B336-744125539EC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42C4-BB45-B336-744125539EC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42C4-BB45-B336-744125539ECD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42C4-BB45-B336-744125539ECD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42C4-BB45-B336-744125539ECD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42C4-BB45-B336-744125539ECD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42C4-BB45-B336-744125539ECD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42C4-BB45-B336-744125539ECD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42C4-BB45-B336-744125539ECD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42C4-BB45-B336-744125539ECD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42C4-BB45-B336-744125539ECD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C-42C4-BB45-B336-744125539ECD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42C4-BB45-B336-744125539ECD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E-42C4-BB45-B336-744125539ECD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42C4-BB45-B336-744125539ECD}"/>
              </c:ext>
            </c:extLst>
          </c:dPt>
          <c:dPt>
            <c:idx val="19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0-42C4-BB45-B336-744125539ECD}"/>
              </c:ext>
            </c:extLst>
          </c:dPt>
          <c:dPt>
            <c:idx val="22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42C4-BB45-B336-744125539ECD}"/>
              </c:ext>
            </c:extLst>
          </c:dPt>
          <c:dPt>
            <c:idx val="45"/>
            <c:invertIfNegative val="0"/>
            <c:bubble3D val="0"/>
            <c:spPr>
              <a:solidFill>
                <a:schemeClr val="accent4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2-42C4-BB45-B336-744125539ECD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E$2:$E$47</c:f>
                <c:numCache>
                  <c:formatCode>General</c:formatCode>
                  <c:ptCount val="46"/>
                  <c:pt idx="0">
                    <c:v>0</c:v>
                  </c:pt>
                  <c:pt idx="1">
                    <c:v>2.5138526357174999E-3</c:v>
                  </c:pt>
                  <c:pt idx="2">
                    <c:v>1.53837062043976E-2</c:v>
                  </c:pt>
                  <c:pt idx="3">
                    <c:v>1.4793973884520507E-2</c:v>
                  </c:pt>
                  <c:pt idx="4">
                    <c:v>3.5039704864513195E-2</c:v>
                  </c:pt>
                  <c:pt idx="5">
                    <c:v>3.2448211358382301E-2</c:v>
                  </c:pt>
                  <c:pt idx="6">
                    <c:v>6.7002341801278203E-2</c:v>
                  </c:pt>
                  <c:pt idx="7">
                    <c:v>6.6223684939541005E-2</c:v>
                  </c:pt>
                  <c:pt idx="8">
                    <c:v>6.023898273107299E-2</c:v>
                  </c:pt>
                  <c:pt idx="9">
                    <c:v>0.13016927596719799</c:v>
                  </c:pt>
                  <c:pt idx="10">
                    <c:v>0.11474224076503599</c:v>
                  </c:pt>
                  <c:pt idx="11">
                    <c:v>3.8753957613447992E-2</c:v>
                  </c:pt>
                  <c:pt idx="12">
                    <c:v>0.11167625797651401</c:v>
                  </c:pt>
                  <c:pt idx="13">
                    <c:v>8.606763400624301E-2</c:v>
                  </c:pt>
                  <c:pt idx="14">
                    <c:v>8.771622572287599E-2</c:v>
                  </c:pt>
                  <c:pt idx="15">
                    <c:v>3.7868615644472969E-2</c:v>
                  </c:pt>
                  <c:pt idx="16">
                    <c:v>0.21260964102964</c:v>
                  </c:pt>
                  <c:pt idx="17">
                    <c:v>6.0869044184622023E-2</c:v>
                  </c:pt>
                  <c:pt idx="18">
                    <c:v>5.0935884364631034E-2</c:v>
                  </c:pt>
                  <c:pt idx="19">
                    <c:v>0.12626181414173304</c:v>
                  </c:pt>
                  <c:pt idx="20">
                    <c:v>0.21757661372089498</c:v>
                  </c:pt>
                  <c:pt idx="21">
                    <c:v>0.27714354943352498</c:v>
                  </c:pt>
                  <c:pt idx="22">
                    <c:v>0.37191418395828602</c:v>
                  </c:pt>
                  <c:pt idx="23">
                    <c:v>0.34774461497173603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  <c:pt idx="38">
                    <c:v>0</c:v>
                  </c:pt>
                  <c:pt idx="39">
                    <c:v>0</c:v>
                  </c:pt>
                  <c:pt idx="40">
                    <c:v>0</c:v>
                  </c:pt>
                  <c:pt idx="41">
                    <c:v>0</c:v>
                  </c:pt>
                  <c:pt idx="42">
                    <c:v>0</c:v>
                  </c:pt>
                  <c:pt idx="43">
                    <c:v>0</c:v>
                  </c:pt>
                  <c:pt idx="44">
                    <c:v>0</c:v>
                  </c:pt>
                  <c:pt idx="45">
                    <c:v>0</c:v>
                  </c:pt>
                </c:numCache>
              </c:numRef>
            </c:plus>
            <c:minus>
              <c:numRef>
                <c:f>Sheet1!$E$2:$E$47</c:f>
                <c:numCache>
                  <c:formatCode>General</c:formatCode>
                  <c:ptCount val="46"/>
                  <c:pt idx="0">
                    <c:v>0</c:v>
                  </c:pt>
                  <c:pt idx="1">
                    <c:v>2.5138526357174999E-3</c:v>
                  </c:pt>
                  <c:pt idx="2">
                    <c:v>1.53837062043976E-2</c:v>
                  </c:pt>
                  <c:pt idx="3">
                    <c:v>1.4793973884520507E-2</c:v>
                  </c:pt>
                  <c:pt idx="4">
                    <c:v>3.5039704864513195E-2</c:v>
                  </c:pt>
                  <c:pt idx="5">
                    <c:v>3.2448211358382301E-2</c:v>
                  </c:pt>
                  <c:pt idx="6">
                    <c:v>6.7002341801278203E-2</c:v>
                  </c:pt>
                  <c:pt idx="7">
                    <c:v>6.6223684939541005E-2</c:v>
                  </c:pt>
                  <c:pt idx="8">
                    <c:v>6.023898273107299E-2</c:v>
                  </c:pt>
                  <c:pt idx="9">
                    <c:v>0.13016927596719799</c:v>
                  </c:pt>
                  <c:pt idx="10">
                    <c:v>0.11474224076503599</c:v>
                  </c:pt>
                  <c:pt idx="11">
                    <c:v>3.8753957613447992E-2</c:v>
                  </c:pt>
                  <c:pt idx="12">
                    <c:v>0.11167625797651401</c:v>
                  </c:pt>
                  <c:pt idx="13">
                    <c:v>8.606763400624301E-2</c:v>
                  </c:pt>
                  <c:pt idx="14">
                    <c:v>8.771622572287599E-2</c:v>
                  </c:pt>
                  <c:pt idx="15">
                    <c:v>3.7868615644472969E-2</c:v>
                  </c:pt>
                  <c:pt idx="16">
                    <c:v>0.21260964102964</c:v>
                  </c:pt>
                  <c:pt idx="17">
                    <c:v>6.0869044184622023E-2</c:v>
                  </c:pt>
                  <c:pt idx="18">
                    <c:v>5.0935884364631034E-2</c:v>
                  </c:pt>
                  <c:pt idx="19">
                    <c:v>0.12626181414173304</c:v>
                  </c:pt>
                  <c:pt idx="20">
                    <c:v>0.21757661372089498</c:v>
                  </c:pt>
                  <c:pt idx="21">
                    <c:v>0.27714354943352498</c:v>
                  </c:pt>
                  <c:pt idx="22">
                    <c:v>0.37191418395828602</c:v>
                  </c:pt>
                  <c:pt idx="23">
                    <c:v>0.34774461497173603</c:v>
                  </c:pt>
                  <c:pt idx="24">
                    <c:v>0</c:v>
                  </c:pt>
                  <c:pt idx="25">
                    <c:v>0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0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0</c:v>
                  </c:pt>
                  <c:pt idx="34">
                    <c:v>0</c:v>
                  </c:pt>
                  <c:pt idx="35">
                    <c:v>0</c:v>
                  </c:pt>
                  <c:pt idx="36">
                    <c:v>0</c:v>
                  </c:pt>
                  <c:pt idx="37">
                    <c:v>0</c:v>
                  </c:pt>
                  <c:pt idx="38">
                    <c:v>0</c:v>
                  </c:pt>
                  <c:pt idx="39">
                    <c:v>0</c:v>
                  </c:pt>
                  <c:pt idx="40">
                    <c:v>0</c:v>
                  </c:pt>
                  <c:pt idx="41">
                    <c:v>0</c:v>
                  </c:pt>
                  <c:pt idx="42">
                    <c:v>0</c:v>
                  </c:pt>
                  <c:pt idx="43">
                    <c:v>0</c:v>
                  </c:pt>
                  <c:pt idx="44">
                    <c:v>0</c:v>
                  </c:pt>
                  <c:pt idx="4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7</c:f>
              <c:strCache>
                <c:ptCount val="46"/>
                <c:pt idx="0">
                  <c:v>HCC2218</c:v>
                </c:pt>
                <c:pt idx="1">
                  <c:v>MDA-MB-175</c:v>
                </c:pt>
                <c:pt idx="2">
                  <c:v>MDA-MB-134</c:v>
                </c:pt>
                <c:pt idx="3">
                  <c:v>UACC-893</c:v>
                </c:pt>
                <c:pt idx="4">
                  <c:v>EFM-19</c:v>
                </c:pt>
                <c:pt idx="5">
                  <c:v>CAMA-1</c:v>
                </c:pt>
                <c:pt idx="6">
                  <c:v>ZR-75-1</c:v>
                </c:pt>
                <c:pt idx="7">
                  <c:v>MDA-MB-415</c:v>
                </c:pt>
                <c:pt idx="8">
                  <c:v>HCC202</c:v>
                </c:pt>
                <c:pt idx="9">
                  <c:v>HCC1419</c:v>
                </c:pt>
                <c:pt idx="10">
                  <c:v>BT-474</c:v>
                </c:pt>
                <c:pt idx="11">
                  <c:v>HCC1500</c:v>
                </c:pt>
                <c:pt idx="12">
                  <c:v>MDA-MB-453</c:v>
                </c:pt>
                <c:pt idx="13">
                  <c:v>EFM-192A</c:v>
                </c:pt>
                <c:pt idx="14">
                  <c:v>T-47D</c:v>
                </c:pt>
                <c:pt idx="15">
                  <c:v>UACC-732</c:v>
                </c:pt>
                <c:pt idx="16">
                  <c:v>MDA-MB-231</c:v>
                </c:pt>
                <c:pt idx="17">
                  <c:v>MCF-7</c:v>
                </c:pt>
                <c:pt idx="18">
                  <c:v>SUM-190</c:v>
                </c:pt>
                <c:pt idx="19">
                  <c:v>MDA-MB-361</c:v>
                </c:pt>
                <c:pt idx="20">
                  <c:v>HCC1395</c:v>
                </c:pt>
                <c:pt idx="21">
                  <c:v>HCC38</c:v>
                </c:pt>
                <c:pt idx="22">
                  <c:v>ZR-75-30</c:v>
                </c:pt>
                <c:pt idx="23">
                  <c:v>HCC1143</c:v>
                </c:pt>
                <c:pt idx="24">
                  <c:v>HCC1569</c:v>
                </c:pt>
                <c:pt idx="25">
                  <c:v>184A1</c:v>
                </c:pt>
                <c:pt idx="26">
                  <c:v>184B5</c:v>
                </c:pt>
                <c:pt idx="27">
                  <c:v>BT-20</c:v>
                </c:pt>
                <c:pt idx="28">
                  <c:v>BT-549</c:v>
                </c:pt>
                <c:pt idx="29">
                  <c:v>CAL-51</c:v>
                </c:pt>
                <c:pt idx="30">
                  <c:v>COLO-824</c:v>
                </c:pt>
                <c:pt idx="31">
                  <c:v>DU4475</c:v>
                </c:pt>
                <c:pt idx="32">
                  <c:v>HCC1187</c:v>
                </c:pt>
                <c:pt idx="33">
                  <c:v>HCC1806</c:v>
                </c:pt>
                <c:pt idx="34">
                  <c:v>HCC1937</c:v>
                </c:pt>
                <c:pt idx="35">
                  <c:v>HCC1954</c:v>
                </c:pt>
                <c:pt idx="36">
                  <c:v>HCC70</c:v>
                </c:pt>
                <c:pt idx="37">
                  <c:v>Hs578T</c:v>
                </c:pt>
                <c:pt idx="38">
                  <c:v>MCF-10A</c:v>
                </c:pt>
                <c:pt idx="39">
                  <c:v>MDA-MB-157</c:v>
                </c:pt>
                <c:pt idx="40">
                  <c:v>MDA-MB-435</c:v>
                </c:pt>
                <c:pt idx="41">
                  <c:v>MDA-MB-436</c:v>
                </c:pt>
                <c:pt idx="42">
                  <c:v>MDA-MB-468</c:v>
                </c:pt>
                <c:pt idx="43">
                  <c:v>SK-BR-3</c:v>
                </c:pt>
                <c:pt idx="44">
                  <c:v>SUM-225</c:v>
                </c:pt>
                <c:pt idx="45">
                  <c:v>UACC-812</c:v>
                </c:pt>
              </c:strCache>
            </c:strRef>
          </c:cat>
          <c:val>
            <c:numRef>
              <c:f>Sheet1!$B$2:$B$47</c:f>
              <c:numCache>
                <c:formatCode>0.00E+00</c:formatCode>
                <c:ptCount val="46"/>
                <c:pt idx="0">
                  <c:v>2.98069999999999E-2</c:v>
                </c:pt>
                <c:pt idx="1">
                  <c:v>3.17138526357175E-2</c:v>
                </c:pt>
                <c:pt idx="2">
                  <c:v>3.54837062043976E-2</c:v>
                </c:pt>
                <c:pt idx="3">
                  <c:v>7.4093973884520506E-2</c:v>
                </c:pt>
                <c:pt idx="4">
                  <c:v>8.1839704864513196E-2</c:v>
                </c:pt>
                <c:pt idx="5">
                  <c:v>8.3848211358382302E-2</c:v>
                </c:pt>
                <c:pt idx="6">
                  <c:v>9.2302341801278207E-2</c:v>
                </c:pt>
                <c:pt idx="7">
                  <c:v>0.10352368493954101</c:v>
                </c:pt>
                <c:pt idx="8">
                  <c:v>0.16523898273107299</c:v>
                </c:pt>
                <c:pt idx="9">
                  <c:v>0.17626927596719799</c:v>
                </c:pt>
                <c:pt idx="10">
                  <c:v>0.19424224076503599</c:v>
                </c:pt>
                <c:pt idx="11">
                  <c:v>0.22075395761344799</c:v>
                </c:pt>
                <c:pt idx="12">
                  <c:v>0.23167625797651401</c:v>
                </c:pt>
                <c:pt idx="13">
                  <c:v>0.28806763400624302</c:v>
                </c:pt>
                <c:pt idx="14">
                  <c:v>0.29171622572287598</c:v>
                </c:pt>
                <c:pt idx="15">
                  <c:v>0.31186861564447299</c:v>
                </c:pt>
                <c:pt idx="16">
                  <c:v>0.36860964102964</c:v>
                </c:pt>
                <c:pt idx="17">
                  <c:v>0.37786904418462203</c:v>
                </c:pt>
                <c:pt idx="18">
                  <c:v>0.41293588436463102</c:v>
                </c:pt>
                <c:pt idx="19">
                  <c:v>0.41426181414173302</c:v>
                </c:pt>
                <c:pt idx="20">
                  <c:v>0.479576613720895</c:v>
                </c:pt>
                <c:pt idx="21">
                  <c:v>0.59014354943352498</c:v>
                </c:pt>
                <c:pt idx="22">
                  <c:v>0.62791418395828602</c:v>
                </c:pt>
                <c:pt idx="23">
                  <c:v>0.69874461497173601</c:v>
                </c:pt>
                <c:pt idx="24">
                  <c:v>0.98033800000000004</c:v>
                </c:pt>
                <c:pt idx="25" formatCode="General">
                  <c:v>1</c:v>
                </c:pt>
                <c:pt idx="26" formatCode="General">
                  <c:v>1</c:v>
                </c:pt>
                <c:pt idx="27" formatCode="General">
                  <c:v>1</c:v>
                </c:pt>
                <c:pt idx="28" formatCode="General">
                  <c:v>1</c:v>
                </c:pt>
                <c:pt idx="29" formatCode="General">
                  <c:v>1</c:v>
                </c:pt>
                <c:pt idx="30" formatCode="General">
                  <c:v>1</c:v>
                </c:pt>
                <c:pt idx="31" formatCode="General">
                  <c:v>1</c:v>
                </c:pt>
                <c:pt idx="32" formatCode="General">
                  <c:v>1</c:v>
                </c:pt>
                <c:pt idx="33" formatCode="General">
                  <c:v>1</c:v>
                </c:pt>
                <c:pt idx="34" formatCode="General">
                  <c:v>1</c:v>
                </c:pt>
                <c:pt idx="35" formatCode="General">
                  <c:v>1</c:v>
                </c:pt>
                <c:pt idx="36" formatCode="General">
                  <c:v>1</c:v>
                </c:pt>
                <c:pt idx="37" formatCode="General">
                  <c:v>1</c:v>
                </c:pt>
                <c:pt idx="38" formatCode="General">
                  <c:v>1</c:v>
                </c:pt>
                <c:pt idx="39" formatCode="General">
                  <c:v>1</c:v>
                </c:pt>
                <c:pt idx="40" formatCode="General">
                  <c:v>1</c:v>
                </c:pt>
                <c:pt idx="41" formatCode="General">
                  <c:v>1</c:v>
                </c:pt>
                <c:pt idx="42" formatCode="General">
                  <c:v>1</c:v>
                </c:pt>
                <c:pt idx="43" formatCode="General">
                  <c:v>1</c:v>
                </c:pt>
                <c:pt idx="44" formatCode="General">
                  <c:v>1</c:v>
                </c:pt>
                <c:pt idx="45" formatCode="General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C4-BB45-B336-744125539E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7"/>
        <c:overlap val="-27"/>
        <c:axId val="985336431"/>
        <c:axId val="985338063"/>
      </c:barChart>
      <c:catAx>
        <c:axId val="98533643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5338063"/>
        <c:crosses val="autoZero"/>
        <c:auto val="1"/>
        <c:lblAlgn val="ctr"/>
        <c:lblOffset val="100"/>
        <c:noMultiLvlLbl val="0"/>
      </c:catAx>
      <c:valAx>
        <c:axId val="985338063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noFill/>
          <a:ln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533643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07C06-B962-C54C-97B3-2B3998DA16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640F6F-BC1F-2745-9F43-1657B6E949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F81DC8-D8AE-9947-8474-D8B362BC1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278CE4-12E5-864C-B8CF-63B9643EB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6D3A7B-4DF7-854C-85D2-56A172DC21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20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2AAAEB-BF3D-E244-B83A-1C0481ECE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911DEB4-B795-764D-B4E7-7ADFBC71F6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DA90D-EFF8-3340-A54E-E7C6A0329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9F47E-6348-8F45-B058-F8BCF24F4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440CDA-51EE-4F4F-883B-79D6117E8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962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8891EC-D4EC-134F-AB95-6B3DE22EBC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FC805AB-B154-F74A-AB94-A4C0447576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208F19-44AD-5A45-A392-378AB667D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4FCB48-F726-CA49-B1CB-D0782E9E6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9D64D8-1EBC-CC4A-B593-FA1039CD5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62361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47F90D-C18D-5740-98A5-B27A992A2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03E94C-D42E-4D41-B69E-21E4423ED5A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164B65-25AC-0A43-94FF-57DBAF9B7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E45249-DA57-C24B-94B6-1F426FBC4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C07587-C9F3-7B4C-AA6E-E372CBF04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4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27EFEC-4E73-D943-8C93-DE5ED5D100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AF5E8B-1707-D949-9A79-AB892FFD51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C7B95E-6D14-834E-898D-58C42E673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ADAD29-9771-6946-BC73-3C7E72E81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52E38-7086-ED40-A51B-7F8307D32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005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0789BF-C663-C24C-811F-7BF7F38A9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E59EA1-F3E3-1C43-B89E-447B1CD724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27A822-4221-AD44-995F-1929C7B124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D48723-8884-104A-B112-A09E361BAB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65A079-6087-774F-8689-5C58606F7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CD96A9-B13C-4A45-B039-449BCD576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76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61DFC7-8890-6941-847D-A1A12AB1F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BD5C99-098C-464B-838A-3A535E50D7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B70A14-5084-6D43-AF3C-42239D36EA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C1113F-E716-6D4D-AB8A-88D341DF53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56F1C75-AACF-C643-A8E4-2A7CD9AFF9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20C7D7-F848-3849-A30C-D7231BC3B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2993F0D-5516-5B46-9ECA-BE6CEB097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9E012C-8E9B-E142-B206-FA9E714E1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74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3FE26D-CFE1-1D40-BFF7-CDA35D31C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B87FF0-34FD-B240-923A-8FFBAD8AD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42EF43-EC2E-7249-9123-D5B2B1C16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AC769D0-6727-0E49-B6F8-115FE4F2A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4736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9F7A6BB-ACC9-7844-B06E-5969B50943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4EDEBA-9056-EF43-9A41-6D9E847F96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55B46E-3995-2242-91A4-470F670C23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606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4172F8-804E-B74E-B9F3-D00DB5F8C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993967-B2B8-8D49-B234-C3C9BE6441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FAD13DC-F7A9-604D-A269-941DA69B5C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C08C22-06B9-B248-A339-78568BB28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48959F-D797-974F-9F2C-17D534425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7B9D67-612A-4545-8EE9-0D264BDA7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157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C43CC8-C557-6C4B-8423-256B1020C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257D83-EB4C-C342-9E27-7641407C53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BF1CE4-A0E7-E745-BA2A-76DF30B8B4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DE5495-5F10-D145-992C-0F5C729858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5BDE29-6792-834A-90C1-D94BF5069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2BBEB0A-17E8-5946-9D64-E55B87281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104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128FB2-913D-474C-87E0-185E2C28D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5453F8-457A-444F-B682-436A888BF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70336F-0A53-7547-BDED-84100D463E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DFD1D-2472-274F-BF10-DE382AA88B56}" type="datetimeFigureOut">
              <a:rPr lang="en-US" smtClean="0"/>
              <a:t>7/3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FD574C-B9C6-464F-BB5D-FC737631AA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26885-AD34-3E40-BE95-5864378239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228970-936D-FC44-90CB-EA587534BF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364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10842999-4A03-274E-8670-A466B0F191FB}"/>
              </a:ext>
            </a:extLst>
          </p:cNvPr>
          <p:cNvGrpSpPr/>
          <p:nvPr/>
        </p:nvGrpSpPr>
        <p:grpSpPr>
          <a:xfrm>
            <a:off x="1814709" y="557211"/>
            <a:ext cx="8686604" cy="4386262"/>
            <a:chOff x="1814709" y="742951"/>
            <a:chExt cx="8686604" cy="4386262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BCF8D6FA-AC07-0346-8E73-ED1D86EDA2B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48044385"/>
                </p:ext>
              </p:extLst>
            </p:nvPr>
          </p:nvGraphicFramePr>
          <p:xfrm>
            <a:off x="2193925" y="742951"/>
            <a:ext cx="8307388" cy="438626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E62E23C-C268-8B4C-83FF-9D38EC065AF8}"/>
                </a:ext>
              </a:extLst>
            </p:cNvPr>
            <p:cNvSpPr txBox="1"/>
            <p:nvPr/>
          </p:nvSpPr>
          <p:spPr>
            <a:xfrm rot="16200000">
              <a:off x="1246444" y="2267727"/>
              <a:ext cx="147508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Log IC</a:t>
              </a:r>
              <a:r>
                <a:rPr lang="en-US" sz="1600" baseline="-25000" dirty="0"/>
                <a:t>50</a:t>
              </a:r>
              <a:r>
                <a:rPr lang="en-US" sz="1600" dirty="0"/>
                <a:t> </a:t>
              </a:r>
              <a:r>
                <a:rPr lang="en-US" sz="1600" dirty="0" err="1"/>
                <a:t>μMol</a:t>
              </a:r>
              <a:r>
                <a:rPr lang="en-US" sz="1600" dirty="0"/>
                <a:t>/L</a:t>
              </a:r>
            </a:p>
          </p:txBody>
        </p: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ADDF8B83-61C5-D346-9CFF-71F5C77B28C5}"/>
                </a:ext>
              </a:extLst>
            </p:cNvPr>
            <p:cNvGrpSpPr/>
            <p:nvPr/>
          </p:nvGrpSpPr>
          <p:grpSpPr>
            <a:xfrm>
              <a:off x="2773179" y="876942"/>
              <a:ext cx="1154835" cy="608843"/>
              <a:chOff x="1629751" y="1379138"/>
              <a:chExt cx="1154835" cy="608843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41535D4F-5F60-4841-A0E4-06980206ADB0}"/>
                  </a:ext>
                </a:extLst>
              </p:cNvPr>
              <p:cNvGrpSpPr/>
              <p:nvPr/>
            </p:nvGrpSpPr>
            <p:grpSpPr>
              <a:xfrm>
                <a:off x="1629751" y="1379138"/>
                <a:ext cx="1154835" cy="307777"/>
                <a:chOff x="1079501" y="6600824"/>
                <a:chExt cx="1154835" cy="307777"/>
              </a:xfrm>
            </p:grpSpPr>
            <p:sp>
              <p:nvSpPr>
                <p:cNvPr id="14" name="Rectangle 13">
                  <a:extLst>
                    <a:ext uri="{FF2B5EF4-FFF2-40B4-BE49-F238E27FC236}">
                      <a16:creationId xmlns:a16="http://schemas.microsoft.com/office/drawing/2014/main" id="{2F95181C-0E95-7042-8A50-0E80B71A8E35}"/>
                    </a:ext>
                  </a:extLst>
                </p:cNvPr>
                <p:cNvSpPr/>
                <p:nvPr/>
              </p:nvSpPr>
              <p:spPr>
                <a:xfrm>
                  <a:off x="1079501" y="6680200"/>
                  <a:ext cx="192438" cy="175399"/>
                </a:xfrm>
                <a:prstGeom prst="rect">
                  <a:avLst/>
                </a:prstGeom>
                <a:solidFill>
                  <a:schemeClr val="accent4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4E59C5FC-7FB2-214C-860D-3807DAFE91CE}"/>
                    </a:ext>
                  </a:extLst>
                </p:cNvPr>
                <p:cNvSpPr txBox="1"/>
                <p:nvPr/>
              </p:nvSpPr>
              <p:spPr>
                <a:xfrm>
                  <a:off x="1218652" y="6600824"/>
                  <a:ext cx="101568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solidFill>
                        <a:srgbClr val="000000"/>
                      </a:solidFill>
                    </a:rPr>
                    <a:t>ER+</a:t>
                  </a:r>
                </a:p>
              </p:txBody>
            </p:sp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CEDC4C68-DC24-044D-8507-55327487BF0F}"/>
                  </a:ext>
                </a:extLst>
              </p:cNvPr>
              <p:cNvGrpSpPr/>
              <p:nvPr/>
            </p:nvGrpSpPr>
            <p:grpSpPr>
              <a:xfrm>
                <a:off x="1629751" y="1680204"/>
                <a:ext cx="1144252" cy="307777"/>
                <a:chOff x="1629751" y="1680204"/>
                <a:chExt cx="1144252" cy="307777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7FB421B0-EF0D-7647-A2A1-7CF258E419FD}"/>
                    </a:ext>
                  </a:extLst>
                </p:cNvPr>
                <p:cNvSpPr txBox="1"/>
                <p:nvPr/>
              </p:nvSpPr>
              <p:spPr>
                <a:xfrm>
                  <a:off x="1779485" y="1680204"/>
                  <a:ext cx="99451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solidFill>
                        <a:srgbClr val="000000"/>
                      </a:solidFill>
                    </a:rPr>
                    <a:t>ER-</a:t>
                  </a:r>
                </a:p>
              </p:txBody>
            </p:sp>
            <p:sp>
              <p:nvSpPr>
                <p:cNvPr id="11" name="Rectangle 10">
                  <a:extLst>
                    <a:ext uri="{FF2B5EF4-FFF2-40B4-BE49-F238E27FC236}">
                      <a16:creationId xmlns:a16="http://schemas.microsoft.com/office/drawing/2014/main" id="{9FF551FF-5B0B-BF43-A5DE-A3EE589C2730}"/>
                    </a:ext>
                  </a:extLst>
                </p:cNvPr>
                <p:cNvSpPr/>
                <p:nvPr/>
              </p:nvSpPr>
              <p:spPr>
                <a:xfrm>
                  <a:off x="1629751" y="1764971"/>
                  <a:ext cx="192438" cy="164618"/>
                </a:xfrm>
                <a:prstGeom prst="rect">
                  <a:avLst/>
                </a:prstGeom>
                <a:solidFill>
                  <a:schemeClr val="accent1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</p:grp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F9F68F42-1AFF-B042-B8B7-63F15C6AB2CD}"/>
                </a:ext>
              </a:extLst>
            </p:cNvPr>
            <p:cNvCxnSpPr>
              <a:cxnSpLocks/>
            </p:cNvCxnSpPr>
            <p:nvPr/>
          </p:nvCxnSpPr>
          <p:spPr>
            <a:xfrm>
              <a:off x="6800850" y="1345083"/>
              <a:ext cx="35147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A194B25-FFE9-604F-9BE8-43498CA3B34D}"/>
                </a:ext>
              </a:extLst>
            </p:cNvPr>
            <p:cNvSpPr txBox="1"/>
            <p:nvPr/>
          </p:nvSpPr>
          <p:spPr>
            <a:xfrm>
              <a:off x="8012557" y="1018491"/>
              <a:ext cx="19601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IC</a:t>
              </a:r>
              <a:r>
                <a:rPr lang="en-US" sz="1400" baseline="-25000" dirty="0"/>
                <a:t>50 </a:t>
              </a:r>
              <a:r>
                <a:rPr lang="en-US" sz="1400" dirty="0"/>
                <a:t>&gt;1µMol/L</a:t>
              </a:r>
              <a:r>
                <a:rPr lang="en-US" sz="1400" baseline="-25000" dirty="0"/>
                <a:t> </a:t>
              </a:r>
              <a:endParaRPr lang="en-US" sz="1400" dirty="0"/>
            </a:p>
          </p:txBody>
        </p:sp>
      </p:grpSp>
      <p:sp>
        <p:nvSpPr>
          <p:cNvPr id="23" name="Rectangle 22">
            <a:extLst>
              <a:ext uri="{FF2B5EF4-FFF2-40B4-BE49-F238E27FC236}">
                <a16:creationId xmlns:a16="http://schemas.microsoft.com/office/drawing/2014/main" id="{8A7D8870-4FB8-A347-9527-FB87C6E07AED}"/>
              </a:ext>
            </a:extLst>
          </p:cNvPr>
          <p:cNvSpPr/>
          <p:nvPr/>
        </p:nvSpPr>
        <p:spPr>
          <a:xfrm>
            <a:off x="2019295" y="5014911"/>
            <a:ext cx="848201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1: Activity of ribociclib (NVP-LEE011) in breast cancer cell lines. </a:t>
            </a:r>
            <a:r>
              <a:rPr lang="en-US" i="1" dirty="0"/>
              <a:t>In vitro </a:t>
            </a:r>
            <a:r>
              <a:rPr lang="en-US" dirty="0"/>
              <a:t>IC</a:t>
            </a:r>
            <a:r>
              <a:rPr lang="en-US" baseline="-25000" dirty="0"/>
              <a:t>50</a:t>
            </a:r>
            <a:r>
              <a:rPr lang="en-US" dirty="0"/>
              <a:t>s (generational inhibition) for each of the breast cell lines. Data represent mean IC50 +/- 95% confidence interval where available. Hormone receptor positive (ER+) cell lines highlighted in yellow. All experiments were repeated in at least duplicate.</a:t>
            </a:r>
          </a:p>
        </p:txBody>
      </p:sp>
    </p:spTree>
    <p:extLst>
      <p:ext uri="{BB962C8B-B14F-4D97-AF65-F5344CB8AC3E}">
        <p14:creationId xmlns:p14="http://schemas.microsoft.com/office/powerpoint/2010/main" val="2247994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77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 Neil</dc:creator>
  <cp:lastModifiedBy>O'Brien, Neil</cp:lastModifiedBy>
  <cp:revision>7</cp:revision>
  <dcterms:created xsi:type="dcterms:W3CDTF">2019-07-31T22:42:50Z</dcterms:created>
  <dcterms:modified xsi:type="dcterms:W3CDTF">2019-07-31T23:23:56Z</dcterms:modified>
</cp:coreProperties>
</file>